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83400" cy="100044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AE094-4CA7-4C47-A611-2A885DF9A80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234CA-DD51-433A-9782-2B0910A008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1FFB0-2696-41CE-9D7B-20F6C290A18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3571A0-1DCB-4970-ABA5-3541A8CBAE8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4D3BA8-09C0-4988-802C-D7509E5297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76D915-8890-4737-A9C4-D31936F515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C78754-067F-4596-B6BE-11EDDE519A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5EBAA-A0F2-4D1E-A647-AB8114A548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B47686-B8C3-4331-B61F-932D0CD094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B42F0-B809-49B5-9EDF-297D941069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320498-E437-431D-9AE3-ADB1E287B6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FDD9E-A371-44DD-8733-0E0BA1BF3C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3622D0-541F-4774-A557-1E22F1DBFA0D}" type="slidenum">
              <a:rPr b="0" lang="el-G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150840" y="115920"/>
            <a:ext cx="6553080" cy="8332920"/>
            <a:chOff x="150840" y="115920"/>
            <a:chExt cx="6553080" cy="8332920"/>
          </a:xfrm>
        </p:grpSpPr>
        <p:grpSp>
          <p:nvGrpSpPr>
            <p:cNvPr id="42" name="Group 156"/>
            <p:cNvGrpSpPr/>
            <p:nvPr/>
          </p:nvGrpSpPr>
          <p:grpSpPr>
            <a:xfrm>
              <a:off x="150840" y="276120"/>
              <a:ext cx="4680000" cy="8172720"/>
              <a:chOff x="150840" y="276120"/>
              <a:chExt cx="4680000" cy="8172720"/>
            </a:xfrm>
          </p:grpSpPr>
          <p:pic>
            <p:nvPicPr>
              <p:cNvPr id="43" name="Picture 5" descr=""/>
              <p:cNvPicPr/>
              <p:nvPr/>
            </p:nvPicPr>
            <p:blipFill>
              <a:blip r:embed="rId1"/>
              <a:srcRect l="3686" t="2094" r="74858" b="0"/>
              <a:stretch/>
            </p:blipFill>
            <p:spPr>
              <a:xfrm>
                <a:off x="150840" y="276120"/>
                <a:ext cx="2232000" cy="81723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5" descr=""/>
              <p:cNvPicPr/>
              <p:nvPr/>
            </p:nvPicPr>
            <p:blipFill>
              <a:blip r:embed="rId2"/>
              <a:srcRect l="30769" t="2094" r="20036" b="0"/>
              <a:stretch/>
            </p:blipFill>
            <p:spPr>
              <a:xfrm>
                <a:off x="1950840" y="276480"/>
                <a:ext cx="2880000" cy="8172360"/>
              </a:xfrm>
              <a:prstGeom prst="rect">
                <a:avLst/>
              </a:prstGeom>
              <a:ln w="0">
                <a:noFill/>
              </a:ln>
            </p:spPr>
          </p:pic>
        </p:grpSp>
        <p:grpSp>
          <p:nvGrpSpPr>
            <p:cNvPr id="45" name="Group 2069"/>
            <p:cNvGrpSpPr/>
            <p:nvPr/>
          </p:nvGrpSpPr>
          <p:grpSpPr>
            <a:xfrm>
              <a:off x="4550760" y="3108240"/>
              <a:ext cx="1628640" cy="215640"/>
              <a:chOff x="4550760" y="3108240"/>
              <a:chExt cx="1628640" cy="215640"/>
            </a:xfrm>
          </p:grpSpPr>
          <p:sp>
            <p:nvSpPr>
              <p:cNvPr id="46" name="Right Brace 30"/>
              <p:cNvSpPr/>
              <p:nvPr/>
            </p:nvSpPr>
            <p:spPr>
              <a:xfrm>
                <a:off x="4550760" y="3186000"/>
                <a:ext cx="155520" cy="8388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2518"/>
                      <a:pt x="10800" y="45035"/>
                    </a:cubicBezTo>
                    <a:lnTo>
                      <a:pt x="10800" y="-34235"/>
                    </a:lnTo>
                    <a:cubicBezTo>
                      <a:pt x="10800" y="-11718"/>
                      <a:pt x="16200" y="10800"/>
                      <a:pt x="21600" y="10800"/>
                    </a:cubicBezTo>
                    <a:cubicBezTo>
                      <a:pt x="16200" y="10800"/>
                      <a:pt x="10800" y="33318"/>
                      <a:pt x="10800" y="55835"/>
                    </a:cubicBezTo>
                    <a:lnTo>
                      <a:pt x="10800" y="-23435"/>
                    </a:lnTo>
                    <a:cubicBezTo>
                      <a:pt x="10800" y="-918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080" bIns="3708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91"/>
              <p:cNvSpPr/>
              <p:nvPr/>
            </p:nvSpPr>
            <p:spPr>
              <a:xfrm>
                <a:off x="4694040" y="310824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6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Group 2070"/>
            <p:cNvGrpSpPr/>
            <p:nvPr/>
          </p:nvGrpSpPr>
          <p:grpSpPr>
            <a:xfrm>
              <a:off x="4550760" y="3250080"/>
              <a:ext cx="1628640" cy="215640"/>
              <a:chOff x="4550760" y="3250080"/>
              <a:chExt cx="1628640" cy="215640"/>
            </a:xfrm>
          </p:grpSpPr>
          <p:sp>
            <p:nvSpPr>
              <p:cNvPr id="49" name="TextBox 92"/>
              <p:cNvSpPr/>
              <p:nvPr/>
            </p:nvSpPr>
            <p:spPr>
              <a:xfrm>
                <a:off x="4694040" y="325008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7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ntilactobacillus kefir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Straight Connector 14"/>
              <p:cNvSpPr/>
              <p:nvPr/>
            </p:nvSpPr>
            <p:spPr>
              <a:xfrm>
                <a:off x="4550760" y="336384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1" name="Group 121"/>
            <p:cNvGrpSpPr/>
            <p:nvPr/>
          </p:nvGrpSpPr>
          <p:grpSpPr>
            <a:xfrm>
              <a:off x="4555080" y="467640"/>
              <a:ext cx="1507680" cy="1665720"/>
              <a:chOff x="4555080" y="467640"/>
              <a:chExt cx="1507680" cy="1665720"/>
            </a:xfrm>
          </p:grpSpPr>
          <p:sp>
            <p:nvSpPr>
              <p:cNvPr id="52" name="Right Brace 20"/>
              <p:cNvSpPr/>
              <p:nvPr/>
            </p:nvSpPr>
            <p:spPr>
              <a:xfrm>
                <a:off x="4555080" y="467640"/>
                <a:ext cx="155520" cy="1665720"/>
              </a:xfrm>
              <a:custGeom>
                <a:avLst/>
                <a:gdLst>
                  <a:gd name="textAreaLeft" fmla="*/ 0 w 155520"/>
                  <a:gd name="textAreaRight" fmla="*/ 56160 w 155520"/>
                  <a:gd name="textAreaTop" fmla="*/ 101520 h 1665720"/>
                  <a:gd name="textAreaBottom" fmla="*/ 1564200 h 16657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104"/>
                      <a:pt x="10800" y="4208"/>
                    </a:cubicBezTo>
                    <a:lnTo>
                      <a:pt x="10800" y="6592"/>
                    </a:lnTo>
                    <a:cubicBezTo>
                      <a:pt x="10800" y="8696"/>
                      <a:pt x="16200" y="10800"/>
                      <a:pt x="21600" y="10800"/>
                    </a:cubicBezTo>
                    <a:cubicBezTo>
                      <a:pt x="16200" y="10800"/>
                      <a:pt x="10800" y="12904"/>
                      <a:pt x="10800" y="15008"/>
                    </a:cubicBezTo>
                    <a:lnTo>
                      <a:pt x="10800" y="17392"/>
                    </a:lnTo>
                    <a:cubicBezTo>
                      <a:pt x="10800" y="19496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29"/>
              <p:cNvSpPr/>
              <p:nvPr/>
            </p:nvSpPr>
            <p:spPr>
              <a:xfrm>
                <a:off x="4733640" y="1187640"/>
                <a:ext cx="13291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ntilactobacillus kefir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" name="Group 120"/>
            <p:cNvGrpSpPr/>
            <p:nvPr/>
          </p:nvGrpSpPr>
          <p:grpSpPr>
            <a:xfrm>
              <a:off x="4281480" y="644040"/>
              <a:ext cx="122400" cy="7627320"/>
              <a:chOff x="4281480" y="644040"/>
              <a:chExt cx="122400" cy="7627320"/>
            </a:xfrm>
          </p:grpSpPr>
          <p:cxnSp>
            <p:nvCxnSpPr>
              <p:cNvPr id="55" name="Straight Arrow Connector 85"/>
              <p:cNvCxnSpPr/>
              <p:nvPr/>
            </p:nvCxnSpPr>
            <p:spPr>
              <a:xfrm>
                <a:off x="4289040" y="8194680"/>
                <a:ext cx="108720" cy="1080"/>
              </a:xfrm>
              <a:prstGeom prst="straightConnector1">
                <a:avLst/>
              </a:prstGeom>
              <a:ln w="3240">
                <a:solidFill>
                  <a:srgbClr val="000000"/>
                </a:solidFill>
                <a:miter/>
                <a:tailEnd len="sm" type="stealth" w="sm"/>
              </a:ln>
            </p:spPr>
          </p:cxnSp>
          <p:grpSp>
            <p:nvGrpSpPr>
              <p:cNvPr id="56" name="Group 119"/>
              <p:cNvGrpSpPr/>
              <p:nvPr/>
            </p:nvGrpSpPr>
            <p:grpSpPr>
              <a:xfrm>
                <a:off x="4281480" y="644040"/>
                <a:ext cx="122400" cy="7627320"/>
                <a:chOff x="4281480" y="644040"/>
                <a:chExt cx="122400" cy="7627320"/>
              </a:xfrm>
            </p:grpSpPr>
            <p:cxnSp>
              <p:nvCxnSpPr>
                <p:cNvPr id="57" name="Straight Arrow Connector 51"/>
                <p:cNvCxnSpPr/>
                <p:nvPr/>
              </p:nvCxnSpPr>
              <p:spPr>
                <a:xfrm>
                  <a:off x="4281480" y="6440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58" name="Straight Arrow Connector 53"/>
                <p:cNvCxnSpPr/>
                <p:nvPr/>
              </p:nvCxnSpPr>
              <p:spPr>
                <a:xfrm>
                  <a:off x="4287600" y="134712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59" name="Straight Arrow Connector 56"/>
                <p:cNvCxnSpPr/>
                <p:nvPr/>
              </p:nvCxnSpPr>
              <p:spPr>
                <a:xfrm>
                  <a:off x="4290840" y="177912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0" name="Straight Arrow Connector 57"/>
                <p:cNvCxnSpPr/>
                <p:nvPr/>
              </p:nvCxnSpPr>
              <p:spPr>
                <a:xfrm>
                  <a:off x="4282920" y="213480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1" name="Straight Arrow Connector 58"/>
                <p:cNvCxnSpPr/>
                <p:nvPr/>
              </p:nvCxnSpPr>
              <p:spPr>
                <a:xfrm>
                  <a:off x="4287600" y="22316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2" name="Straight Arrow Connector 59"/>
                <p:cNvCxnSpPr/>
                <p:nvPr/>
              </p:nvCxnSpPr>
              <p:spPr>
                <a:xfrm>
                  <a:off x="4286160" y="248724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3" name="Straight Arrow Connector 60"/>
                <p:cNvCxnSpPr/>
                <p:nvPr/>
              </p:nvCxnSpPr>
              <p:spPr>
                <a:xfrm>
                  <a:off x="4287600" y="266328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4" name="Straight Arrow Connector 61"/>
                <p:cNvCxnSpPr/>
                <p:nvPr/>
              </p:nvCxnSpPr>
              <p:spPr>
                <a:xfrm>
                  <a:off x="4286160" y="301248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5" name="Straight Arrow Connector 62"/>
                <p:cNvCxnSpPr/>
                <p:nvPr/>
              </p:nvCxnSpPr>
              <p:spPr>
                <a:xfrm>
                  <a:off x="4286160" y="310140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6" name="Straight Arrow Connector 63"/>
                <p:cNvCxnSpPr/>
                <p:nvPr/>
              </p:nvCxnSpPr>
              <p:spPr>
                <a:xfrm>
                  <a:off x="4287600" y="327780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7" name="Straight Arrow Connector 64"/>
                <p:cNvCxnSpPr/>
                <p:nvPr/>
              </p:nvCxnSpPr>
              <p:spPr>
                <a:xfrm>
                  <a:off x="4290840" y="336672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8" name="Straight Arrow Connector 65"/>
                <p:cNvCxnSpPr/>
                <p:nvPr/>
              </p:nvCxnSpPr>
              <p:spPr>
                <a:xfrm>
                  <a:off x="4287600" y="37191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69" name="Straight Arrow Connector 66"/>
                <p:cNvCxnSpPr/>
                <p:nvPr/>
              </p:nvCxnSpPr>
              <p:spPr>
                <a:xfrm>
                  <a:off x="4290840" y="407160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0" name="Straight Arrow Connector 67"/>
                <p:cNvCxnSpPr/>
                <p:nvPr/>
              </p:nvCxnSpPr>
              <p:spPr>
                <a:xfrm>
                  <a:off x="4290840" y="415404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1" name="Straight Arrow Connector 68"/>
                <p:cNvCxnSpPr/>
                <p:nvPr/>
              </p:nvCxnSpPr>
              <p:spPr>
                <a:xfrm>
                  <a:off x="4287600" y="441288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2" name="Straight Arrow Connector 69"/>
                <p:cNvCxnSpPr/>
                <p:nvPr/>
              </p:nvCxnSpPr>
              <p:spPr>
                <a:xfrm>
                  <a:off x="4287600" y="485568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3" name="Straight Arrow Connector 70"/>
                <p:cNvCxnSpPr/>
                <p:nvPr/>
              </p:nvCxnSpPr>
              <p:spPr>
                <a:xfrm>
                  <a:off x="4286160" y="529416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4" name="Straight Arrow Connector 71"/>
                <p:cNvCxnSpPr/>
                <p:nvPr/>
              </p:nvCxnSpPr>
              <p:spPr>
                <a:xfrm>
                  <a:off x="4286160" y="53859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5" name="Straight Arrow Connector 72"/>
                <p:cNvCxnSpPr/>
                <p:nvPr/>
              </p:nvCxnSpPr>
              <p:spPr>
                <a:xfrm>
                  <a:off x="4287600" y="57369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6" name="Straight Arrow Connector 73"/>
                <p:cNvCxnSpPr/>
                <p:nvPr/>
              </p:nvCxnSpPr>
              <p:spPr>
                <a:xfrm>
                  <a:off x="4294080" y="58179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7" name="Straight Arrow Connector 74"/>
                <p:cNvCxnSpPr/>
                <p:nvPr/>
              </p:nvCxnSpPr>
              <p:spPr>
                <a:xfrm>
                  <a:off x="4287600" y="59990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8" name="Straight Arrow Connector 75"/>
                <p:cNvCxnSpPr/>
                <p:nvPr/>
              </p:nvCxnSpPr>
              <p:spPr>
                <a:xfrm>
                  <a:off x="4287600" y="60782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79" name="Straight Arrow Connector 76"/>
                <p:cNvCxnSpPr/>
                <p:nvPr/>
              </p:nvCxnSpPr>
              <p:spPr>
                <a:xfrm>
                  <a:off x="4290840" y="68738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0" name="Straight Arrow Connector 77"/>
                <p:cNvCxnSpPr/>
                <p:nvPr/>
              </p:nvCxnSpPr>
              <p:spPr>
                <a:xfrm>
                  <a:off x="4290840" y="660708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1" name="Straight Arrow Connector 78"/>
                <p:cNvCxnSpPr/>
                <p:nvPr/>
              </p:nvCxnSpPr>
              <p:spPr>
                <a:xfrm>
                  <a:off x="4286160" y="696096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2" name="Straight Arrow Connector 79"/>
                <p:cNvCxnSpPr/>
                <p:nvPr/>
              </p:nvCxnSpPr>
              <p:spPr>
                <a:xfrm>
                  <a:off x="4287600" y="713412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3" name="Straight Arrow Connector 80"/>
                <p:cNvCxnSpPr/>
                <p:nvPr/>
              </p:nvCxnSpPr>
              <p:spPr>
                <a:xfrm>
                  <a:off x="4287600" y="731520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4" name="Straight Arrow Connector 81"/>
                <p:cNvCxnSpPr/>
                <p:nvPr/>
              </p:nvCxnSpPr>
              <p:spPr>
                <a:xfrm>
                  <a:off x="4287600" y="748980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5" name="Straight Arrow Connector 82"/>
                <p:cNvCxnSpPr/>
                <p:nvPr/>
              </p:nvCxnSpPr>
              <p:spPr>
                <a:xfrm>
                  <a:off x="4287600" y="774540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6" name="Straight Arrow Connector 83"/>
                <p:cNvCxnSpPr/>
                <p:nvPr/>
              </p:nvCxnSpPr>
              <p:spPr>
                <a:xfrm>
                  <a:off x="4290840" y="801828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7" name="Straight Arrow Connector 84"/>
                <p:cNvCxnSpPr/>
                <p:nvPr/>
              </p:nvCxnSpPr>
              <p:spPr>
                <a:xfrm>
                  <a:off x="4290840" y="810108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88" name="Straight Arrow Connector 86"/>
                <p:cNvCxnSpPr/>
                <p:nvPr/>
              </p:nvCxnSpPr>
              <p:spPr>
                <a:xfrm>
                  <a:off x="4290840" y="8270640"/>
                  <a:ext cx="10872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</p:grpSp>
        </p:grpSp>
        <p:grpSp>
          <p:nvGrpSpPr>
            <p:cNvPr id="89" name="Group 122"/>
            <p:cNvGrpSpPr/>
            <p:nvPr/>
          </p:nvGrpSpPr>
          <p:grpSpPr>
            <a:xfrm>
              <a:off x="4549680" y="2105640"/>
              <a:ext cx="2080800" cy="215640"/>
              <a:chOff x="4549680" y="2105640"/>
              <a:chExt cx="2080800" cy="215640"/>
            </a:xfrm>
          </p:grpSpPr>
          <p:sp>
            <p:nvSpPr>
              <p:cNvPr id="90" name="Straight Connector 7"/>
              <p:cNvSpPr/>
              <p:nvPr/>
            </p:nvSpPr>
            <p:spPr>
              <a:xfrm>
                <a:off x="4549680" y="222084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87"/>
              <p:cNvSpPr/>
              <p:nvPr/>
            </p:nvSpPr>
            <p:spPr>
              <a:xfrm>
                <a:off x="4713840" y="2105640"/>
                <a:ext cx="1916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/pseudo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2" name="Group 123"/>
            <p:cNvGrpSpPr/>
            <p:nvPr/>
          </p:nvGrpSpPr>
          <p:grpSpPr>
            <a:xfrm>
              <a:off x="4550760" y="2307960"/>
              <a:ext cx="1473480" cy="614520"/>
              <a:chOff x="4550760" y="2307960"/>
              <a:chExt cx="1473480" cy="614520"/>
            </a:xfrm>
          </p:grpSpPr>
          <p:sp>
            <p:nvSpPr>
              <p:cNvPr id="93" name="Right Brace 22"/>
              <p:cNvSpPr/>
              <p:nvPr/>
            </p:nvSpPr>
            <p:spPr>
              <a:xfrm>
                <a:off x="4550760" y="2307960"/>
                <a:ext cx="155520" cy="614520"/>
              </a:xfrm>
              <a:custGeom>
                <a:avLst/>
                <a:gdLst>
                  <a:gd name="textAreaLeft" fmla="*/ 0 w 155520"/>
                  <a:gd name="textAreaRight" fmla="*/ 56160 w 155520"/>
                  <a:gd name="textAreaTop" fmla="*/ 101520 h 614520"/>
                  <a:gd name="textAreaBottom" fmla="*/ 513000 h 61452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5703"/>
                      <a:pt x="10800" y="11405"/>
                    </a:cubicBezTo>
                    <a:lnTo>
                      <a:pt x="10800" y="-605"/>
                    </a:lnTo>
                    <a:cubicBezTo>
                      <a:pt x="10800" y="5098"/>
                      <a:pt x="16200" y="10800"/>
                      <a:pt x="21600" y="10800"/>
                    </a:cubicBezTo>
                    <a:cubicBezTo>
                      <a:pt x="16200" y="10800"/>
                      <a:pt x="10800" y="16503"/>
                      <a:pt x="10800" y="22205"/>
                    </a:cubicBezTo>
                    <a:lnTo>
                      <a:pt x="10800" y="10195"/>
                    </a:lnTo>
                    <a:cubicBezTo>
                      <a:pt x="10800" y="15898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TextBox 88"/>
              <p:cNvSpPr/>
              <p:nvPr/>
            </p:nvSpPr>
            <p:spPr>
              <a:xfrm>
                <a:off x="4694040" y="250992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ntilactobacillus kefir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5" name="Group 124"/>
            <p:cNvGrpSpPr/>
            <p:nvPr/>
          </p:nvGrpSpPr>
          <p:grpSpPr>
            <a:xfrm>
              <a:off x="4549680" y="2869200"/>
              <a:ext cx="2080800" cy="215640"/>
              <a:chOff x="4549680" y="2869200"/>
              <a:chExt cx="2080800" cy="215640"/>
            </a:xfrm>
          </p:grpSpPr>
          <p:sp>
            <p:nvSpPr>
              <p:cNvPr id="96" name="Straight Connector 9"/>
              <p:cNvSpPr/>
              <p:nvPr/>
            </p:nvSpPr>
            <p:spPr>
              <a:xfrm>
                <a:off x="4549680" y="301320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Box 89"/>
              <p:cNvSpPr/>
              <p:nvPr/>
            </p:nvSpPr>
            <p:spPr>
              <a:xfrm>
                <a:off x="4694400" y="2869200"/>
                <a:ext cx="193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4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/pseudo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8" name="Group 125"/>
            <p:cNvGrpSpPr/>
            <p:nvPr/>
          </p:nvGrpSpPr>
          <p:grpSpPr>
            <a:xfrm>
              <a:off x="4550760" y="2993040"/>
              <a:ext cx="1628640" cy="215640"/>
              <a:chOff x="4550760" y="2993040"/>
              <a:chExt cx="1628640" cy="215640"/>
            </a:xfrm>
          </p:grpSpPr>
          <p:sp>
            <p:nvSpPr>
              <p:cNvPr id="99" name="Straight Connector 11"/>
              <p:cNvSpPr/>
              <p:nvPr/>
            </p:nvSpPr>
            <p:spPr>
              <a:xfrm>
                <a:off x="4550760" y="310032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TextBox 90"/>
              <p:cNvSpPr/>
              <p:nvPr/>
            </p:nvSpPr>
            <p:spPr>
              <a:xfrm>
                <a:off x="4694040" y="299304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5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eptococcus parauberi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1" name="Group 2048"/>
            <p:cNvGrpSpPr/>
            <p:nvPr/>
          </p:nvGrpSpPr>
          <p:grpSpPr>
            <a:xfrm>
              <a:off x="4565880" y="3451320"/>
              <a:ext cx="1458360" cy="450360"/>
              <a:chOff x="4565880" y="3451320"/>
              <a:chExt cx="1458360" cy="450360"/>
            </a:xfrm>
          </p:grpSpPr>
          <p:sp>
            <p:nvSpPr>
              <p:cNvPr id="102" name="Right Brace 32"/>
              <p:cNvSpPr/>
              <p:nvPr/>
            </p:nvSpPr>
            <p:spPr>
              <a:xfrm>
                <a:off x="4565880" y="3451320"/>
                <a:ext cx="155520" cy="450360"/>
              </a:xfrm>
              <a:custGeom>
                <a:avLst/>
                <a:gdLst>
                  <a:gd name="textAreaLeft" fmla="*/ 0 w 155520"/>
                  <a:gd name="textAreaRight" fmla="*/ 56160 w 155520"/>
                  <a:gd name="textAreaTop" fmla="*/ 101160 h 450360"/>
                  <a:gd name="textAreaBottom" fmla="*/ 349200 h 45036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7771"/>
                      <a:pt x="10800" y="15542"/>
                    </a:cubicBezTo>
                    <a:lnTo>
                      <a:pt x="10800" y="-4742"/>
                    </a:lnTo>
                    <a:cubicBezTo>
                      <a:pt x="10800" y="3029"/>
                      <a:pt x="16200" y="10800"/>
                      <a:pt x="21600" y="10800"/>
                    </a:cubicBezTo>
                    <a:cubicBezTo>
                      <a:pt x="16200" y="10800"/>
                      <a:pt x="10800" y="18571"/>
                      <a:pt x="10800" y="26342"/>
                    </a:cubicBezTo>
                    <a:lnTo>
                      <a:pt x="10800" y="6058"/>
                    </a:lnTo>
                    <a:cubicBezTo>
                      <a:pt x="10800" y="13829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TextBox 94"/>
              <p:cNvSpPr/>
              <p:nvPr/>
            </p:nvSpPr>
            <p:spPr>
              <a:xfrm>
                <a:off x="4694760" y="3565440"/>
                <a:ext cx="1329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8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actococcus lacti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4" name="Group 2049"/>
            <p:cNvGrpSpPr/>
            <p:nvPr/>
          </p:nvGrpSpPr>
          <p:grpSpPr>
            <a:xfrm>
              <a:off x="4565520" y="3902400"/>
              <a:ext cx="2138400" cy="215640"/>
              <a:chOff x="4565520" y="3902400"/>
              <a:chExt cx="2138400" cy="215640"/>
            </a:xfrm>
          </p:grpSpPr>
          <p:sp>
            <p:nvSpPr>
              <p:cNvPr id="105" name="Right Brace 31"/>
              <p:cNvSpPr/>
              <p:nvPr/>
            </p:nvSpPr>
            <p:spPr>
              <a:xfrm>
                <a:off x="4565520" y="3968640"/>
                <a:ext cx="155520" cy="10296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2518"/>
                      <a:pt x="10800" y="45035"/>
                    </a:cubicBezTo>
                    <a:lnTo>
                      <a:pt x="10800" y="-34235"/>
                    </a:lnTo>
                    <a:cubicBezTo>
                      <a:pt x="10800" y="-11718"/>
                      <a:pt x="16200" y="10800"/>
                      <a:pt x="21600" y="10800"/>
                    </a:cubicBezTo>
                    <a:cubicBezTo>
                      <a:pt x="16200" y="10800"/>
                      <a:pt x="10800" y="33318"/>
                      <a:pt x="10800" y="55835"/>
                    </a:cubicBezTo>
                    <a:lnTo>
                      <a:pt x="10800" y="-23435"/>
                    </a:lnTo>
                    <a:cubicBezTo>
                      <a:pt x="10800" y="-918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Box 95"/>
              <p:cNvSpPr/>
              <p:nvPr/>
            </p:nvSpPr>
            <p:spPr>
              <a:xfrm>
                <a:off x="4713840" y="3902400"/>
                <a:ext cx="1990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9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/pseudo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7" name="Group 2071"/>
            <p:cNvGrpSpPr/>
            <p:nvPr/>
          </p:nvGrpSpPr>
          <p:grpSpPr>
            <a:xfrm>
              <a:off x="4550760" y="4047840"/>
              <a:ext cx="1473480" cy="215640"/>
              <a:chOff x="4550760" y="4047840"/>
              <a:chExt cx="1473480" cy="215640"/>
            </a:xfrm>
          </p:grpSpPr>
          <p:sp>
            <p:nvSpPr>
              <p:cNvPr id="108" name="Straight Connector 16"/>
              <p:cNvSpPr/>
              <p:nvPr/>
            </p:nvSpPr>
            <p:spPr>
              <a:xfrm>
                <a:off x="4550760" y="415764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TextBox 96"/>
              <p:cNvSpPr/>
              <p:nvPr/>
            </p:nvSpPr>
            <p:spPr>
              <a:xfrm>
                <a:off x="4694040" y="404784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0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ntilactobacillus kefir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0" name="Group 2051"/>
            <p:cNvGrpSpPr/>
            <p:nvPr/>
          </p:nvGrpSpPr>
          <p:grpSpPr>
            <a:xfrm>
              <a:off x="4551480" y="4238640"/>
              <a:ext cx="1472760" cy="971280"/>
              <a:chOff x="4551480" y="4238640"/>
              <a:chExt cx="1472760" cy="971280"/>
            </a:xfrm>
          </p:grpSpPr>
          <p:sp>
            <p:nvSpPr>
              <p:cNvPr id="111" name="Right Brace 33"/>
              <p:cNvSpPr/>
              <p:nvPr/>
            </p:nvSpPr>
            <p:spPr>
              <a:xfrm>
                <a:off x="4551480" y="4238640"/>
                <a:ext cx="155520" cy="971280"/>
              </a:xfrm>
              <a:custGeom>
                <a:avLst/>
                <a:gdLst>
                  <a:gd name="textAreaLeft" fmla="*/ 0 w 155520"/>
                  <a:gd name="textAreaRight" fmla="*/ 56160 w 155520"/>
                  <a:gd name="textAreaTop" fmla="*/ 101520 h 971280"/>
                  <a:gd name="textAreaBottom" fmla="*/ 869760 h 97128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3606"/>
                      <a:pt x="10800" y="7212"/>
                    </a:cubicBezTo>
                    <a:lnTo>
                      <a:pt x="10800" y="3588"/>
                    </a:lnTo>
                    <a:cubicBezTo>
                      <a:pt x="10800" y="7194"/>
                      <a:pt x="16200" y="10800"/>
                      <a:pt x="21600" y="10800"/>
                    </a:cubicBezTo>
                    <a:cubicBezTo>
                      <a:pt x="16200" y="10800"/>
                      <a:pt x="10800" y="14406"/>
                      <a:pt x="10800" y="18012"/>
                    </a:cubicBezTo>
                    <a:lnTo>
                      <a:pt x="10800" y="14388"/>
                    </a:lnTo>
                    <a:cubicBezTo>
                      <a:pt x="10800" y="17994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TextBox 97"/>
              <p:cNvSpPr/>
              <p:nvPr/>
            </p:nvSpPr>
            <p:spPr>
              <a:xfrm>
                <a:off x="4694760" y="4598640"/>
                <a:ext cx="13294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1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acticaseibacillus rhamnosu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3" name="Group 2053"/>
            <p:cNvGrpSpPr/>
            <p:nvPr/>
          </p:nvGrpSpPr>
          <p:grpSpPr>
            <a:xfrm>
              <a:off x="4550760" y="5175000"/>
              <a:ext cx="1473480" cy="215640"/>
              <a:chOff x="4550760" y="5175000"/>
              <a:chExt cx="1473480" cy="215640"/>
            </a:xfrm>
          </p:grpSpPr>
          <p:sp>
            <p:nvSpPr>
              <p:cNvPr id="114" name="Straight Connector 34"/>
              <p:cNvSpPr/>
              <p:nvPr/>
            </p:nvSpPr>
            <p:spPr>
              <a:xfrm>
                <a:off x="4550760" y="529452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TextBox 98"/>
              <p:cNvSpPr/>
              <p:nvPr/>
            </p:nvSpPr>
            <p:spPr>
              <a:xfrm>
                <a:off x="4694040" y="517500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2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Klebsiella oxytoca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6" name="Group 2054"/>
            <p:cNvGrpSpPr/>
            <p:nvPr/>
          </p:nvGrpSpPr>
          <p:grpSpPr>
            <a:xfrm>
              <a:off x="4560120" y="5351760"/>
              <a:ext cx="1464120" cy="215640"/>
              <a:chOff x="4560120" y="5351760"/>
              <a:chExt cx="1464120" cy="215640"/>
            </a:xfrm>
          </p:grpSpPr>
          <p:sp>
            <p:nvSpPr>
              <p:cNvPr id="117" name="Right Brace 35"/>
              <p:cNvSpPr/>
              <p:nvPr/>
            </p:nvSpPr>
            <p:spPr>
              <a:xfrm>
                <a:off x="4560120" y="5378400"/>
                <a:ext cx="155160" cy="18108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19359"/>
                      <a:pt x="10800" y="38717"/>
                    </a:cubicBezTo>
                    <a:lnTo>
                      <a:pt x="10800" y="-27917"/>
                    </a:lnTo>
                    <a:cubicBezTo>
                      <a:pt x="10800" y="-8559"/>
                      <a:pt x="16200" y="10800"/>
                      <a:pt x="21600" y="10800"/>
                    </a:cubicBezTo>
                    <a:cubicBezTo>
                      <a:pt x="16200" y="10800"/>
                      <a:pt x="10800" y="30159"/>
                      <a:pt x="10800" y="49517"/>
                    </a:cubicBezTo>
                    <a:lnTo>
                      <a:pt x="10800" y="-17117"/>
                    </a:lnTo>
                    <a:cubicBezTo>
                      <a:pt x="10800" y="2242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Box 99"/>
              <p:cNvSpPr/>
              <p:nvPr/>
            </p:nvSpPr>
            <p:spPr>
              <a:xfrm>
                <a:off x="4695480" y="5351760"/>
                <a:ext cx="1328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3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eptococcus thermophilu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9" name="Group 2057"/>
            <p:cNvGrpSpPr/>
            <p:nvPr/>
          </p:nvGrpSpPr>
          <p:grpSpPr>
            <a:xfrm>
              <a:off x="4550760" y="5841720"/>
              <a:ext cx="1473480" cy="215640"/>
              <a:chOff x="4550760" y="5841720"/>
              <a:chExt cx="1473480" cy="215640"/>
            </a:xfrm>
          </p:grpSpPr>
          <p:sp>
            <p:nvSpPr>
              <p:cNvPr id="120" name="Right Brace 38"/>
              <p:cNvSpPr/>
              <p:nvPr/>
            </p:nvSpPr>
            <p:spPr>
              <a:xfrm>
                <a:off x="4550760" y="5892840"/>
                <a:ext cx="155520" cy="10944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2518"/>
                      <a:pt x="10800" y="45035"/>
                    </a:cubicBezTo>
                    <a:lnTo>
                      <a:pt x="10800" y="-34235"/>
                    </a:lnTo>
                    <a:cubicBezTo>
                      <a:pt x="10800" y="-11718"/>
                      <a:pt x="16200" y="10800"/>
                      <a:pt x="21600" y="10800"/>
                    </a:cubicBezTo>
                    <a:cubicBezTo>
                      <a:pt x="16200" y="10800"/>
                      <a:pt x="10800" y="33318"/>
                      <a:pt x="10800" y="55835"/>
                    </a:cubicBezTo>
                    <a:lnTo>
                      <a:pt x="10800" y="-23435"/>
                    </a:lnTo>
                    <a:cubicBezTo>
                      <a:pt x="10800" y="-918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TextBox 100"/>
              <p:cNvSpPr/>
              <p:nvPr/>
            </p:nvSpPr>
            <p:spPr>
              <a:xfrm>
                <a:off x="4694040" y="584172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6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aphylococcus warner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2" name="Group 2055"/>
            <p:cNvGrpSpPr/>
            <p:nvPr/>
          </p:nvGrpSpPr>
          <p:grpSpPr>
            <a:xfrm>
              <a:off x="4550760" y="5587920"/>
              <a:ext cx="1473480" cy="215640"/>
              <a:chOff x="4550760" y="5587920"/>
              <a:chExt cx="1473480" cy="215640"/>
            </a:xfrm>
          </p:grpSpPr>
          <p:sp>
            <p:nvSpPr>
              <p:cNvPr id="123" name="Right Brace 36"/>
              <p:cNvSpPr/>
              <p:nvPr/>
            </p:nvSpPr>
            <p:spPr>
              <a:xfrm>
                <a:off x="4550760" y="5648400"/>
                <a:ext cx="155520" cy="10296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2518"/>
                      <a:pt x="10800" y="45035"/>
                    </a:cubicBezTo>
                    <a:lnTo>
                      <a:pt x="10800" y="-34235"/>
                    </a:lnTo>
                    <a:cubicBezTo>
                      <a:pt x="10800" y="-11718"/>
                      <a:pt x="16200" y="10800"/>
                      <a:pt x="21600" y="10800"/>
                    </a:cubicBezTo>
                    <a:cubicBezTo>
                      <a:pt x="16200" y="10800"/>
                      <a:pt x="10800" y="33318"/>
                      <a:pt x="10800" y="55835"/>
                    </a:cubicBezTo>
                    <a:lnTo>
                      <a:pt x="10800" y="-23435"/>
                    </a:lnTo>
                    <a:cubicBezTo>
                      <a:pt x="10800" y="-918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TextBox 101"/>
              <p:cNvSpPr/>
              <p:nvPr/>
            </p:nvSpPr>
            <p:spPr>
              <a:xfrm>
                <a:off x="4694040" y="558792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4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eptococcus thermophilu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5" name="Group 2056"/>
            <p:cNvGrpSpPr/>
            <p:nvPr/>
          </p:nvGrpSpPr>
          <p:grpSpPr>
            <a:xfrm>
              <a:off x="4550760" y="5711760"/>
              <a:ext cx="1473480" cy="215640"/>
              <a:chOff x="4550760" y="5711760"/>
              <a:chExt cx="1473480" cy="215640"/>
            </a:xfrm>
          </p:grpSpPr>
          <p:sp>
            <p:nvSpPr>
              <p:cNvPr id="126" name="Straight Connector 37"/>
              <p:cNvSpPr/>
              <p:nvPr/>
            </p:nvSpPr>
            <p:spPr>
              <a:xfrm>
                <a:off x="4550760" y="582156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" name="TextBox 102"/>
              <p:cNvSpPr/>
              <p:nvPr/>
            </p:nvSpPr>
            <p:spPr>
              <a:xfrm>
                <a:off x="4694040" y="571176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5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eptococcus thermophilu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28" name="Group 2058"/>
            <p:cNvGrpSpPr/>
            <p:nvPr/>
          </p:nvGrpSpPr>
          <p:grpSpPr>
            <a:xfrm>
              <a:off x="4550760" y="6015240"/>
              <a:ext cx="1473480" cy="215640"/>
              <a:chOff x="4550760" y="6015240"/>
              <a:chExt cx="1473480" cy="215640"/>
            </a:xfrm>
          </p:grpSpPr>
          <p:sp>
            <p:nvSpPr>
              <p:cNvPr id="129" name="Right Brace 39"/>
              <p:cNvSpPr/>
              <p:nvPr/>
            </p:nvSpPr>
            <p:spPr>
              <a:xfrm>
                <a:off x="4550760" y="6073920"/>
                <a:ext cx="155520" cy="10944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2518"/>
                      <a:pt x="10800" y="45035"/>
                    </a:cubicBezTo>
                    <a:lnTo>
                      <a:pt x="10800" y="-34235"/>
                    </a:lnTo>
                    <a:cubicBezTo>
                      <a:pt x="10800" y="-11718"/>
                      <a:pt x="16200" y="10800"/>
                      <a:pt x="21600" y="10800"/>
                    </a:cubicBezTo>
                    <a:cubicBezTo>
                      <a:pt x="16200" y="10800"/>
                      <a:pt x="10800" y="33318"/>
                      <a:pt x="10800" y="55835"/>
                    </a:cubicBezTo>
                    <a:lnTo>
                      <a:pt x="10800" y="-23435"/>
                    </a:lnTo>
                    <a:cubicBezTo>
                      <a:pt x="10800" y="-918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TextBox 103"/>
              <p:cNvSpPr/>
              <p:nvPr/>
            </p:nvSpPr>
            <p:spPr>
              <a:xfrm>
                <a:off x="4694040" y="601524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7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treptococcus thermophilu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1" name="Group 2059"/>
            <p:cNvGrpSpPr/>
            <p:nvPr/>
          </p:nvGrpSpPr>
          <p:grpSpPr>
            <a:xfrm>
              <a:off x="4550760" y="6249960"/>
              <a:ext cx="1628640" cy="529200"/>
              <a:chOff x="4550760" y="6249960"/>
              <a:chExt cx="1628640" cy="529200"/>
            </a:xfrm>
          </p:grpSpPr>
          <p:sp>
            <p:nvSpPr>
              <p:cNvPr id="132" name="Right Brace 40"/>
              <p:cNvSpPr/>
              <p:nvPr/>
            </p:nvSpPr>
            <p:spPr>
              <a:xfrm>
                <a:off x="4550760" y="6249960"/>
                <a:ext cx="155520" cy="529200"/>
              </a:xfrm>
              <a:custGeom>
                <a:avLst/>
                <a:gdLst>
                  <a:gd name="textAreaLeft" fmla="*/ 0 w 155520"/>
                  <a:gd name="textAreaRight" fmla="*/ 56160 w 155520"/>
                  <a:gd name="textAreaTop" fmla="*/ 101520 h 529200"/>
                  <a:gd name="textAreaBottom" fmla="*/ 427680 h 52920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6628"/>
                      <a:pt x="10800" y="13255"/>
                    </a:cubicBezTo>
                    <a:lnTo>
                      <a:pt x="10800" y="-2455"/>
                    </a:lnTo>
                    <a:cubicBezTo>
                      <a:pt x="10800" y="4173"/>
                      <a:pt x="16200" y="10800"/>
                      <a:pt x="21600" y="10800"/>
                    </a:cubicBezTo>
                    <a:cubicBezTo>
                      <a:pt x="16200" y="10800"/>
                      <a:pt x="10800" y="17428"/>
                      <a:pt x="10800" y="24055"/>
                    </a:cubicBezTo>
                    <a:lnTo>
                      <a:pt x="10800" y="8345"/>
                    </a:lnTo>
                    <a:cubicBezTo>
                      <a:pt x="10800" y="14973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TextBox 104"/>
              <p:cNvSpPr/>
              <p:nvPr/>
            </p:nvSpPr>
            <p:spPr>
              <a:xfrm>
                <a:off x="4694040" y="639900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8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4" name="Group 2060"/>
            <p:cNvGrpSpPr/>
            <p:nvPr/>
          </p:nvGrpSpPr>
          <p:grpSpPr>
            <a:xfrm>
              <a:off x="4550760" y="6759360"/>
              <a:ext cx="1473480" cy="215640"/>
              <a:chOff x="4550760" y="6759360"/>
              <a:chExt cx="1473480" cy="215640"/>
            </a:xfrm>
          </p:grpSpPr>
          <p:sp>
            <p:nvSpPr>
              <p:cNvPr id="135" name="Straight Connector 41"/>
              <p:cNvSpPr/>
              <p:nvPr/>
            </p:nvSpPr>
            <p:spPr>
              <a:xfrm>
                <a:off x="4550760" y="687420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TextBox 105"/>
              <p:cNvSpPr/>
              <p:nvPr/>
            </p:nvSpPr>
            <p:spPr>
              <a:xfrm>
                <a:off x="4694040" y="6759360"/>
                <a:ext cx="1330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9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ntilactobacillus kefiri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7" name="Group 2061"/>
            <p:cNvGrpSpPr/>
            <p:nvPr/>
          </p:nvGrpSpPr>
          <p:grpSpPr>
            <a:xfrm>
              <a:off x="4550760" y="6941520"/>
              <a:ext cx="1628640" cy="215640"/>
              <a:chOff x="4550760" y="6941520"/>
              <a:chExt cx="1628640" cy="215640"/>
            </a:xfrm>
          </p:grpSpPr>
          <p:sp>
            <p:nvSpPr>
              <p:cNvPr id="138" name="Right Brace 42"/>
              <p:cNvSpPr/>
              <p:nvPr/>
            </p:nvSpPr>
            <p:spPr>
              <a:xfrm>
                <a:off x="4550760" y="6959880"/>
                <a:ext cx="155520" cy="18108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19359"/>
                      <a:pt x="10800" y="38717"/>
                    </a:cubicBezTo>
                    <a:lnTo>
                      <a:pt x="10800" y="-27917"/>
                    </a:lnTo>
                    <a:cubicBezTo>
                      <a:pt x="10800" y="-8559"/>
                      <a:pt x="16200" y="10800"/>
                      <a:pt x="21600" y="10800"/>
                    </a:cubicBezTo>
                    <a:cubicBezTo>
                      <a:pt x="16200" y="10800"/>
                      <a:pt x="10800" y="30159"/>
                      <a:pt x="10800" y="49517"/>
                    </a:cubicBezTo>
                    <a:lnTo>
                      <a:pt x="10800" y="-17117"/>
                    </a:lnTo>
                    <a:cubicBezTo>
                      <a:pt x="10800" y="2242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TextBox 106"/>
              <p:cNvSpPr/>
              <p:nvPr/>
            </p:nvSpPr>
            <p:spPr>
              <a:xfrm>
                <a:off x="4694040" y="694152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0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0" name="Group 2062"/>
            <p:cNvGrpSpPr/>
            <p:nvPr/>
          </p:nvGrpSpPr>
          <p:grpSpPr>
            <a:xfrm>
              <a:off x="4550760" y="7147440"/>
              <a:ext cx="1628640" cy="215640"/>
              <a:chOff x="4550760" y="7147440"/>
              <a:chExt cx="1628640" cy="215640"/>
            </a:xfrm>
          </p:grpSpPr>
          <p:sp>
            <p:nvSpPr>
              <p:cNvPr id="141" name="Right Brace 44"/>
              <p:cNvSpPr/>
              <p:nvPr/>
            </p:nvSpPr>
            <p:spPr>
              <a:xfrm>
                <a:off x="4550760" y="7207560"/>
                <a:ext cx="155520" cy="10800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22518"/>
                      <a:pt x="10800" y="45035"/>
                    </a:cubicBezTo>
                    <a:lnTo>
                      <a:pt x="10800" y="-34235"/>
                    </a:lnTo>
                    <a:cubicBezTo>
                      <a:pt x="10800" y="-11718"/>
                      <a:pt x="16200" y="10800"/>
                      <a:pt x="21600" y="10800"/>
                    </a:cubicBezTo>
                    <a:cubicBezTo>
                      <a:pt x="16200" y="10800"/>
                      <a:pt x="10800" y="33318"/>
                      <a:pt x="10800" y="55835"/>
                    </a:cubicBezTo>
                    <a:lnTo>
                      <a:pt x="10800" y="-23435"/>
                    </a:lnTo>
                    <a:cubicBezTo>
                      <a:pt x="10800" y="-918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2" name="TextBox 107"/>
              <p:cNvSpPr/>
              <p:nvPr/>
            </p:nvSpPr>
            <p:spPr>
              <a:xfrm>
                <a:off x="4694040" y="714744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1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3" name="Group 2063"/>
            <p:cNvGrpSpPr/>
            <p:nvPr/>
          </p:nvGrpSpPr>
          <p:grpSpPr>
            <a:xfrm>
              <a:off x="4549680" y="7373520"/>
              <a:ext cx="2080800" cy="215640"/>
              <a:chOff x="4549680" y="7373520"/>
              <a:chExt cx="2080800" cy="215640"/>
            </a:xfrm>
          </p:grpSpPr>
          <p:sp>
            <p:nvSpPr>
              <p:cNvPr id="144" name="Right Brace 43"/>
              <p:cNvSpPr/>
              <p:nvPr/>
            </p:nvSpPr>
            <p:spPr>
              <a:xfrm>
                <a:off x="4549680" y="7394760"/>
                <a:ext cx="155520" cy="179280"/>
              </a:xfrm>
              <a:custGeom>
                <a:avLst/>
                <a:gdLst/>
                <a:ahLst/>
                <a:rect l="l" t="t" r="r" b="b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19530"/>
                      <a:pt x="10800" y="39060"/>
                    </a:cubicBezTo>
                    <a:lnTo>
                      <a:pt x="10800" y="-28260"/>
                    </a:lnTo>
                    <a:cubicBezTo>
                      <a:pt x="10800" y="-8730"/>
                      <a:pt x="16200" y="10800"/>
                      <a:pt x="21600" y="10800"/>
                    </a:cubicBezTo>
                    <a:cubicBezTo>
                      <a:pt x="16200" y="10800"/>
                      <a:pt x="10800" y="30330"/>
                      <a:pt x="10800" y="49860"/>
                    </a:cubicBezTo>
                    <a:lnTo>
                      <a:pt x="10800" y="-17460"/>
                    </a:lnTo>
                    <a:cubicBezTo>
                      <a:pt x="10800" y="2070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TextBox 108"/>
              <p:cNvSpPr/>
              <p:nvPr/>
            </p:nvSpPr>
            <p:spPr>
              <a:xfrm>
                <a:off x="4694400" y="7373520"/>
                <a:ext cx="19360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2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/pseudo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6" name="Group 2064"/>
            <p:cNvGrpSpPr/>
            <p:nvPr/>
          </p:nvGrpSpPr>
          <p:grpSpPr>
            <a:xfrm>
              <a:off x="4550760" y="7659000"/>
              <a:ext cx="1628640" cy="271440"/>
              <a:chOff x="4550760" y="7659000"/>
              <a:chExt cx="1628640" cy="271440"/>
            </a:xfrm>
          </p:grpSpPr>
          <p:sp>
            <p:nvSpPr>
              <p:cNvPr id="147" name="Right Brace 49"/>
              <p:cNvSpPr/>
              <p:nvPr/>
            </p:nvSpPr>
            <p:spPr>
              <a:xfrm>
                <a:off x="4550760" y="7659000"/>
                <a:ext cx="155520" cy="271440"/>
              </a:xfrm>
              <a:custGeom>
                <a:avLst/>
                <a:gdLst>
                  <a:gd name="textAreaLeft" fmla="*/ 0 w 155520"/>
                  <a:gd name="textAreaRight" fmla="*/ 56160 w 155520"/>
                  <a:gd name="textAreaTop" fmla="*/ 101520 h 271440"/>
                  <a:gd name="textAreaBottom" fmla="*/ 169920 h 271440"/>
                </a:gdLst>
                <a:ahLst/>
                <a:rect l="textAreaLeft" t="textAreaTop" r="textAreaRight" b="textAreaBottom"/>
                <a:pathLst>
                  <a:path w="21600" h="21600">
                    <a:moveTo>
                      <a:pt x="0" y="0"/>
                    </a:moveTo>
                    <a:cubicBezTo>
                      <a:pt x="5400" y="0"/>
                      <a:pt x="10800" y="12906"/>
                      <a:pt x="10800" y="25812"/>
                    </a:cubicBezTo>
                    <a:lnTo>
                      <a:pt x="10800" y="-15012"/>
                    </a:lnTo>
                    <a:cubicBezTo>
                      <a:pt x="10800" y="-2106"/>
                      <a:pt x="16200" y="10800"/>
                      <a:pt x="21600" y="10800"/>
                    </a:cubicBezTo>
                    <a:cubicBezTo>
                      <a:pt x="16200" y="10800"/>
                      <a:pt x="10800" y="23706"/>
                      <a:pt x="10800" y="36612"/>
                    </a:cubicBezTo>
                    <a:lnTo>
                      <a:pt x="10800" y="-4212"/>
                    </a:lnTo>
                    <a:cubicBezTo>
                      <a:pt x="10800" y="8694"/>
                      <a:pt x="5400" y="21600"/>
                      <a:pt x="0" y="21600"/>
                    </a:cubicBezTo>
                  </a:path>
                </a:pathLst>
              </a:cu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600" bIns="216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" name="TextBox 109"/>
              <p:cNvSpPr/>
              <p:nvPr/>
            </p:nvSpPr>
            <p:spPr>
              <a:xfrm>
                <a:off x="4694040" y="767700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3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nterobacter </a:t>
                </a:r>
                <a:r>
                  <a:rPr b="0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pp.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9" name="Group 2065"/>
            <p:cNvGrpSpPr/>
            <p:nvPr/>
          </p:nvGrpSpPr>
          <p:grpSpPr>
            <a:xfrm>
              <a:off x="4546080" y="7902000"/>
              <a:ext cx="1633320" cy="215640"/>
              <a:chOff x="4546080" y="7902000"/>
              <a:chExt cx="1633320" cy="215640"/>
            </a:xfrm>
          </p:grpSpPr>
          <p:sp>
            <p:nvSpPr>
              <p:cNvPr id="150" name="Straight Connector 48"/>
              <p:cNvSpPr/>
              <p:nvPr/>
            </p:nvSpPr>
            <p:spPr>
              <a:xfrm>
                <a:off x="4546080" y="802188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TextBox 110"/>
              <p:cNvSpPr/>
              <p:nvPr/>
            </p:nvSpPr>
            <p:spPr>
              <a:xfrm>
                <a:off x="4694040" y="790200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4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2" name="Group 2068"/>
            <p:cNvGrpSpPr/>
            <p:nvPr/>
          </p:nvGrpSpPr>
          <p:grpSpPr>
            <a:xfrm>
              <a:off x="4550760" y="8088480"/>
              <a:ext cx="1628640" cy="215640"/>
              <a:chOff x="4550760" y="8088480"/>
              <a:chExt cx="1628640" cy="215640"/>
            </a:xfrm>
          </p:grpSpPr>
          <p:sp>
            <p:nvSpPr>
              <p:cNvPr id="153" name="Straight Connector 46"/>
              <p:cNvSpPr/>
              <p:nvPr/>
            </p:nvSpPr>
            <p:spPr>
              <a:xfrm>
                <a:off x="4550760" y="819972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TextBox 111"/>
              <p:cNvSpPr/>
              <p:nvPr/>
            </p:nvSpPr>
            <p:spPr>
              <a:xfrm>
                <a:off x="4694040" y="8088480"/>
                <a:ext cx="14853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6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euconostoc mesenteroide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5" name="Group 2066"/>
            <p:cNvGrpSpPr/>
            <p:nvPr/>
          </p:nvGrpSpPr>
          <p:grpSpPr>
            <a:xfrm>
              <a:off x="4550040" y="8001720"/>
              <a:ext cx="1629360" cy="215640"/>
              <a:chOff x="4550040" y="8001720"/>
              <a:chExt cx="1629360" cy="215640"/>
            </a:xfrm>
          </p:grpSpPr>
          <p:sp>
            <p:nvSpPr>
              <p:cNvPr id="156" name="Straight Connector 47"/>
              <p:cNvSpPr/>
              <p:nvPr/>
            </p:nvSpPr>
            <p:spPr>
              <a:xfrm>
                <a:off x="4550040" y="810756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" name="TextBox 112"/>
              <p:cNvSpPr/>
              <p:nvPr/>
            </p:nvSpPr>
            <p:spPr>
              <a:xfrm>
                <a:off x="4694760" y="8001720"/>
                <a:ext cx="1484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5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actococcus reffinolacti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58" name="Group 2067"/>
            <p:cNvGrpSpPr/>
            <p:nvPr/>
          </p:nvGrpSpPr>
          <p:grpSpPr>
            <a:xfrm>
              <a:off x="4549680" y="8184240"/>
              <a:ext cx="1629720" cy="215640"/>
              <a:chOff x="4549680" y="8184240"/>
              <a:chExt cx="1629720" cy="215640"/>
            </a:xfrm>
          </p:grpSpPr>
          <p:sp>
            <p:nvSpPr>
              <p:cNvPr id="159" name="Straight Connector 45"/>
              <p:cNvSpPr/>
              <p:nvPr/>
            </p:nvSpPr>
            <p:spPr>
              <a:xfrm>
                <a:off x="4549680" y="8283600"/>
                <a:ext cx="187200" cy="0"/>
              </a:xfrm>
              <a:prstGeom prst="line">
                <a:avLst/>
              </a:prstGeom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" name="TextBox 113"/>
              <p:cNvSpPr/>
              <p:nvPr/>
            </p:nvSpPr>
            <p:spPr>
              <a:xfrm>
                <a:off x="4694400" y="8184240"/>
                <a:ext cx="14850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7 </a:t>
                </a:r>
                <a:r>
                  <a:rPr b="1" lang="el-GR" sz="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</a:t>
                </a:r>
                <a:r>
                  <a:rPr b="0" i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Lactococcus lactis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1" name="Group 116"/>
            <p:cNvGrpSpPr/>
            <p:nvPr/>
          </p:nvGrpSpPr>
          <p:grpSpPr>
            <a:xfrm>
              <a:off x="4118760" y="115920"/>
              <a:ext cx="1800000" cy="279360"/>
              <a:chOff x="4118760" y="115920"/>
              <a:chExt cx="1800000" cy="279360"/>
            </a:xfrm>
          </p:grpSpPr>
          <p:sp>
            <p:nvSpPr>
              <p:cNvPr id="162" name="TextBox 114"/>
              <p:cNvSpPr/>
              <p:nvPr/>
            </p:nvSpPr>
            <p:spPr>
              <a:xfrm>
                <a:off x="4118760" y="115920"/>
                <a:ext cx="65232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ACA-DC strain number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" name="TextBox 93"/>
              <p:cNvSpPr/>
              <p:nvPr/>
            </p:nvSpPr>
            <p:spPr>
              <a:xfrm>
                <a:off x="4671000" y="118440"/>
                <a:ext cx="52740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p-PCR Cluster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TextBox 117"/>
              <p:cNvSpPr/>
              <p:nvPr/>
            </p:nvSpPr>
            <p:spPr>
              <a:xfrm>
                <a:off x="5145840" y="164520"/>
                <a:ext cx="7729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6S Identification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65" name="TextBox 118"/>
          <p:cNvSpPr/>
          <p:nvPr/>
        </p:nvSpPr>
        <p:spPr>
          <a:xfrm>
            <a:off x="192240" y="8459640"/>
            <a:ext cx="64753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. 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rep-PCR fingerprinting of bacterial isolates using the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Calibri"/>
              </a:rPr>
              <a:t>BOXAIR primer. Image analysis was performed using BioNumerics v. 6.0. Arrows denote isolates, which were selected for 16S rRNA gene sequencin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6" name="Group 2"/>
          <p:cNvGrpSpPr/>
          <p:nvPr/>
        </p:nvGrpSpPr>
        <p:grpSpPr>
          <a:xfrm>
            <a:off x="225360" y="701640"/>
            <a:ext cx="6408720" cy="5754600"/>
            <a:chOff x="225360" y="701640"/>
            <a:chExt cx="6408720" cy="5754600"/>
          </a:xfrm>
        </p:grpSpPr>
        <p:pic>
          <p:nvPicPr>
            <p:cNvPr id="167" name="Picture 4" descr=""/>
            <p:cNvPicPr/>
            <p:nvPr/>
          </p:nvPicPr>
          <p:blipFill>
            <a:blip r:embed="rId1"/>
            <a:srcRect l="5667" t="19148" r="20835" b="0"/>
            <a:stretch/>
          </p:blipFill>
          <p:spPr>
            <a:xfrm>
              <a:off x="225360" y="839520"/>
              <a:ext cx="4535640" cy="5616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68" name="Group 2"/>
            <p:cNvGrpSpPr/>
            <p:nvPr/>
          </p:nvGrpSpPr>
          <p:grpSpPr>
            <a:xfrm>
              <a:off x="4113720" y="701640"/>
              <a:ext cx="2520360" cy="5505840"/>
              <a:chOff x="4113720" y="701640"/>
              <a:chExt cx="2520360" cy="5505840"/>
            </a:xfrm>
          </p:grpSpPr>
          <p:grpSp>
            <p:nvGrpSpPr>
              <p:cNvPr id="169" name="Group 42"/>
              <p:cNvGrpSpPr/>
              <p:nvPr/>
            </p:nvGrpSpPr>
            <p:grpSpPr>
              <a:xfrm>
                <a:off x="4227120" y="1199520"/>
                <a:ext cx="115920" cy="4817520"/>
                <a:chOff x="4227120" y="1199520"/>
                <a:chExt cx="115920" cy="4817520"/>
              </a:xfrm>
            </p:grpSpPr>
            <p:cxnSp>
              <p:nvCxnSpPr>
                <p:cNvPr id="170" name="Straight Arrow Connector 5"/>
                <p:cNvCxnSpPr/>
                <p:nvPr/>
              </p:nvCxnSpPr>
              <p:spPr>
                <a:xfrm>
                  <a:off x="4227120" y="119952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1" name="Straight Arrow Connector 8"/>
                <p:cNvCxnSpPr/>
                <p:nvPr/>
              </p:nvCxnSpPr>
              <p:spPr>
                <a:xfrm>
                  <a:off x="4233240" y="135828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2" name="Straight Arrow Connector 9"/>
                <p:cNvCxnSpPr/>
                <p:nvPr/>
              </p:nvCxnSpPr>
              <p:spPr>
                <a:xfrm>
                  <a:off x="4233240" y="15170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3" name="Straight Arrow Connector 10"/>
                <p:cNvCxnSpPr/>
                <p:nvPr/>
              </p:nvCxnSpPr>
              <p:spPr>
                <a:xfrm>
                  <a:off x="4227120" y="16851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4" name="Straight Arrow Connector 11"/>
                <p:cNvCxnSpPr/>
                <p:nvPr/>
              </p:nvCxnSpPr>
              <p:spPr>
                <a:xfrm>
                  <a:off x="4227120" y="19947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5" name="Straight Arrow Connector 12"/>
                <p:cNvCxnSpPr/>
                <p:nvPr/>
              </p:nvCxnSpPr>
              <p:spPr>
                <a:xfrm>
                  <a:off x="4233240" y="215820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6" name="Straight Arrow Connector 13"/>
                <p:cNvCxnSpPr/>
                <p:nvPr/>
              </p:nvCxnSpPr>
              <p:spPr>
                <a:xfrm>
                  <a:off x="4227120" y="24789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7" name="Straight Arrow Connector 14"/>
                <p:cNvCxnSpPr/>
                <p:nvPr/>
              </p:nvCxnSpPr>
              <p:spPr>
                <a:xfrm>
                  <a:off x="4230000" y="31251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8" name="Straight Arrow Connector 15"/>
                <p:cNvCxnSpPr/>
                <p:nvPr/>
              </p:nvCxnSpPr>
              <p:spPr>
                <a:xfrm>
                  <a:off x="4227120" y="42429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79" name="Straight Arrow Connector 16"/>
                <p:cNvCxnSpPr/>
                <p:nvPr/>
              </p:nvCxnSpPr>
              <p:spPr>
                <a:xfrm>
                  <a:off x="4227120" y="440640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80" name="Straight Arrow Connector 17"/>
                <p:cNvCxnSpPr/>
                <p:nvPr/>
              </p:nvCxnSpPr>
              <p:spPr>
                <a:xfrm>
                  <a:off x="4227120" y="45716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81" name="Straight Arrow Connector 18"/>
                <p:cNvCxnSpPr/>
                <p:nvPr/>
              </p:nvCxnSpPr>
              <p:spPr>
                <a:xfrm>
                  <a:off x="4227120" y="47289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82" name="Straight Arrow Connector 19"/>
                <p:cNvCxnSpPr/>
                <p:nvPr/>
              </p:nvCxnSpPr>
              <p:spPr>
                <a:xfrm>
                  <a:off x="4227120" y="505116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83" name="Straight Arrow Connector 20"/>
                <p:cNvCxnSpPr/>
                <p:nvPr/>
              </p:nvCxnSpPr>
              <p:spPr>
                <a:xfrm>
                  <a:off x="4227120" y="568944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  <p:cxnSp>
              <p:nvCxnSpPr>
                <p:cNvPr id="184" name="Straight Arrow Connector 21"/>
                <p:cNvCxnSpPr/>
                <p:nvPr/>
              </p:nvCxnSpPr>
              <p:spPr>
                <a:xfrm>
                  <a:off x="4227120" y="6016320"/>
                  <a:ext cx="110160" cy="1080"/>
                </a:xfrm>
                <a:prstGeom prst="straightConnector1">
                  <a:avLst/>
                </a:prstGeom>
                <a:ln w="3240">
                  <a:solidFill>
                    <a:srgbClr val="000000"/>
                  </a:solidFill>
                  <a:miter/>
                  <a:tailEnd len="sm" type="stealth" w="sm"/>
                </a:ln>
              </p:spPr>
            </p:cxnSp>
          </p:grpSp>
          <p:grpSp>
            <p:nvGrpSpPr>
              <p:cNvPr id="185" name="Group 1"/>
              <p:cNvGrpSpPr/>
              <p:nvPr/>
            </p:nvGrpSpPr>
            <p:grpSpPr>
              <a:xfrm>
                <a:off x="4113720" y="701640"/>
                <a:ext cx="2520360" cy="5505840"/>
                <a:chOff x="4113720" y="701640"/>
                <a:chExt cx="2520360" cy="5505840"/>
              </a:xfrm>
            </p:grpSpPr>
            <p:grpSp>
              <p:nvGrpSpPr>
                <p:cNvPr id="186" name="Group 7"/>
                <p:cNvGrpSpPr/>
                <p:nvPr/>
              </p:nvGrpSpPr>
              <p:grpSpPr>
                <a:xfrm>
                  <a:off x="4113720" y="701640"/>
                  <a:ext cx="1738440" cy="276840"/>
                  <a:chOff x="4113720" y="701640"/>
                  <a:chExt cx="1738440" cy="276840"/>
                </a:xfrm>
              </p:grpSpPr>
              <p:sp>
                <p:nvSpPr>
                  <p:cNvPr id="187" name="TextBox 114"/>
                  <p:cNvSpPr/>
                  <p:nvPr/>
                </p:nvSpPr>
                <p:spPr>
                  <a:xfrm>
                    <a:off x="4113720" y="701640"/>
                    <a:ext cx="652680" cy="2768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 algn="ctr"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ACA-DC strain number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TextBox 93"/>
                  <p:cNvSpPr/>
                  <p:nvPr/>
                </p:nvSpPr>
                <p:spPr>
                  <a:xfrm>
                    <a:off x="4690080" y="701640"/>
                    <a:ext cx="527760" cy="2768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Rep-PCR Cluster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TextBox 117"/>
                  <p:cNvSpPr/>
                  <p:nvPr/>
                </p:nvSpPr>
                <p:spPr>
                  <a:xfrm>
                    <a:off x="5078880" y="739800"/>
                    <a:ext cx="77328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ITS Identification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90" name="Group 44"/>
                <p:cNvGrpSpPr/>
                <p:nvPr/>
              </p:nvGrpSpPr>
              <p:grpSpPr>
                <a:xfrm>
                  <a:off x="4618440" y="1172880"/>
                  <a:ext cx="187200" cy="5018400"/>
                  <a:chOff x="4618440" y="1172880"/>
                  <a:chExt cx="187200" cy="5018400"/>
                </a:xfrm>
              </p:grpSpPr>
              <p:sp>
                <p:nvSpPr>
                  <p:cNvPr id="191" name="Right Brace 22"/>
                  <p:cNvSpPr/>
                  <p:nvPr/>
                </p:nvSpPr>
                <p:spPr>
                  <a:xfrm>
                    <a:off x="4618440" y="1172880"/>
                    <a:ext cx="155520" cy="344520"/>
                  </a:xfrm>
                  <a:custGeom>
                    <a:avLst/>
                    <a:gdLst>
                      <a:gd name="textAreaLeft" fmla="*/ 0 w 155520"/>
                      <a:gd name="textAreaRight" fmla="*/ 56160 w 155520"/>
                      <a:gd name="textAreaTop" fmla="*/ 101520 h 344520"/>
                      <a:gd name="textAreaBottom" fmla="*/ 243000 h 3445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10170"/>
                          <a:pt x="10800" y="20340"/>
                        </a:cubicBezTo>
                        <a:lnTo>
                          <a:pt x="10800" y="-9540"/>
                        </a:lnTo>
                        <a:cubicBezTo>
                          <a:pt x="10800" y="630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20970"/>
                          <a:pt x="10800" y="31140"/>
                        </a:cubicBezTo>
                        <a:lnTo>
                          <a:pt x="10800" y="1260"/>
                        </a:lnTo>
                        <a:cubicBezTo>
                          <a:pt x="10800" y="11430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Right Brace 23"/>
                  <p:cNvSpPr/>
                  <p:nvPr/>
                </p:nvSpPr>
                <p:spPr>
                  <a:xfrm>
                    <a:off x="4618440" y="1649160"/>
                    <a:ext cx="155520" cy="180720"/>
                  </a:xfrm>
                  <a:custGeom>
                    <a:avLst/>
                    <a:gdLst/>
                    <a:ahLst/>
                    <a:rect l="l" t="t" r="r" b="b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19359"/>
                          <a:pt x="10800" y="38717"/>
                        </a:cubicBezTo>
                        <a:lnTo>
                          <a:pt x="10800" y="-27917"/>
                        </a:lnTo>
                        <a:cubicBezTo>
                          <a:pt x="10800" y="-8559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30159"/>
                          <a:pt x="10800" y="49517"/>
                        </a:cubicBezTo>
                        <a:lnTo>
                          <a:pt x="10800" y="-17117"/>
                        </a:lnTo>
                        <a:cubicBezTo>
                          <a:pt x="10800" y="2242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Straight Connector 24"/>
                  <p:cNvSpPr/>
                  <p:nvPr/>
                </p:nvSpPr>
                <p:spPr>
                  <a:xfrm>
                    <a:off x="4618440" y="2003040"/>
                    <a:ext cx="18720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Straight Connector 25"/>
                  <p:cNvSpPr/>
                  <p:nvPr/>
                </p:nvSpPr>
                <p:spPr>
                  <a:xfrm>
                    <a:off x="4618440" y="2158560"/>
                    <a:ext cx="18720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5" name="Right Brace 26"/>
                  <p:cNvSpPr/>
                  <p:nvPr/>
                </p:nvSpPr>
                <p:spPr>
                  <a:xfrm>
                    <a:off x="4618440" y="2314440"/>
                    <a:ext cx="155520" cy="1622520"/>
                  </a:xfrm>
                  <a:custGeom>
                    <a:avLst/>
                    <a:gdLst>
                      <a:gd name="textAreaLeft" fmla="*/ 0 w 155520"/>
                      <a:gd name="textAreaRight" fmla="*/ 56160 w 155520"/>
                      <a:gd name="textAreaTop" fmla="*/ 101520 h 1622520"/>
                      <a:gd name="textAreaBottom" fmla="*/ 1521000 h 162252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2160"/>
                          <a:pt x="10800" y="4319"/>
                        </a:cubicBezTo>
                        <a:lnTo>
                          <a:pt x="10800" y="6481"/>
                        </a:lnTo>
                        <a:cubicBezTo>
                          <a:pt x="10800" y="8641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2960"/>
                          <a:pt x="10800" y="15119"/>
                        </a:cubicBezTo>
                        <a:lnTo>
                          <a:pt x="10800" y="17281"/>
                        </a:lnTo>
                        <a:cubicBezTo>
                          <a:pt x="10800" y="19441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6" name="Right Brace 27"/>
                  <p:cNvSpPr/>
                  <p:nvPr/>
                </p:nvSpPr>
                <p:spPr>
                  <a:xfrm>
                    <a:off x="4618440" y="4075200"/>
                    <a:ext cx="155520" cy="180720"/>
                  </a:xfrm>
                  <a:custGeom>
                    <a:avLst/>
                    <a:gdLst/>
                    <a:ahLst/>
                    <a:rect l="l" t="t" r="r" b="b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19359"/>
                          <a:pt x="10800" y="38717"/>
                        </a:cubicBezTo>
                        <a:lnTo>
                          <a:pt x="10800" y="-27917"/>
                        </a:lnTo>
                        <a:cubicBezTo>
                          <a:pt x="10800" y="-8559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30159"/>
                          <a:pt x="10800" y="49517"/>
                        </a:cubicBezTo>
                        <a:lnTo>
                          <a:pt x="10800" y="-17117"/>
                        </a:lnTo>
                        <a:cubicBezTo>
                          <a:pt x="10800" y="2242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7" name="Straight Connector 28"/>
                  <p:cNvSpPr/>
                  <p:nvPr/>
                </p:nvSpPr>
                <p:spPr>
                  <a:xfrm>
                    <a:off x="4618440" y="4406760"/>
                    <a:ext cx="187200" cy="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8" name="Right Brace 29"/>
                  <p:cNvSpPr/>
                  <p:nvPr/>
                </p:nvSpPr>
                <p:spPr>
                  <a:xfrm>
                    <a:off x="4618440" y="4567320"/>
                    <a:ext cx="155520" cy="630000"/>
                  </a:xfrm>
                  <a:custGeom>
                    <a:avLst/>
                    <a:gdLst>
                      <a:gd name="textAreaLeft" fmla="*/ 0 w 155520"/>
                      <a:gd name="textAreaRight" fmla="*/ 56160 w 155520"/>
                      <a:gd name="textAreaTop" fmla="*/ 101520 h 630000"/>
                      <a:gd name="textAreaBottom" fmla="*/ 528480 h 63000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5559"/>
                          <a:pt x="10800" y="11118"/>
                        </a:cubicBezTo>
                        <a:lnTo>
                          <a:pt x="10800" y="-318"/>
                        </a:lnTo>
                        <a:cubicBezTo>
                          <a:pt x="10800" y="5241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6359"/>
                          <a:pt x="10800" y="21918"/>
                        </a:cubicBezTo>
                        <a:lnTo>
                          <a:pt x="10800" y="10482"/>
                        </a:lnTo>
                        <a:cubicBezTo>
                          <a:pt x="10800" y="16041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Right Brace 30"/>
                  <p:cNvSpPr/>
                  <p:nvPr/>
                </p:nvSpPr>
                <p:spPr>
                  <a:xfrm>
                    <a:off x="4618440" y="5361120"/>
                    <a:ext cx="155520" cy="482400"/>
                  </a:xfrm>
                  <a:custGeom>
                    <a:avLst/>
                    <a:gdLst>
                      <a:gd name="textAreaLeft" fmla="*/ 0 w 155520"/>
                      <a:gd name="textAreaRight" fmla="*/ 56160 w 155520"/>
                      <a:gd name="textAreaTop" fmla="*/ 101520 h 482400"/>
                      <a:gd name="textAreaBottom" fmla="*/ 380880 h 482400"/>
                    </a:gdLst>
                    <a:ahLst/>
                    <a:rect l="textAreaLeft" t="textAreaTop" r="textAreaRight" b="textAreaBottom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7260"/>
                          <a:pt x="10800" y="14519"/>
                        </a:cubicBezTo>
                        <a:lnTo>
                          <a:pt x="10800" y="-3719"/>
                        </a:lnTo>
                        <a:cubicBezTo>
                          <a:pt x="10800" y="3541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18060"/>
                          <a:pt x="10800" y="25319"/>
                        </a:cubicBezTo>
                        <a:lnTo>
                          <a:pt x="10800" y="7081"/>
                        </a:lnTo>
                        <a:cubicBezTo>
                          <a:pt x="10800" y="14341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Right Brace 31"/>
                  <p:cNvSpPr/>
                  <p:nvPr/>
                </p:nvSpPr>
                <p:spPr>
                  <a:xfrm>
                    <a:off x="4618440" y="6010560"/>
                    <a:ext cx="155520" cy="180720"/>
                  </a:xfrm>
                  <a:custGeom>
                    <a:avLst/>
                    <a:gdLst/>
                    <a:ahLst/>
                    <a:rect l="l" t="t" r="r" b="b"/>
                    <a:pathLst>
                      <a:path w="21600" h="21600">
                        <a:moveTo>
                          <a:pt x="0" y="0"/>
                        </a:moveTo>
                        <a:cubicBezTo>
                          <a:pt x="5400" y="0"/>
                          <a:pt x="10800" y="19359"/>
                          <a:pt x="10800" y="38717"/>
                        </a:cubicBezTo>
                        <a:lnTo>
                          <a:pt x="10800" y="-27917"/>
                        </a:lnTo>
                        <a:cubicBezTo>
                          <a:pt x="10800" y="-8559"/>
                          <a:pt x="16200" y="10800"/>
                          <a:pt x="21600" y="10800"/>
                        </a:cubicBezTo>
                        <a:cubicBezTo>
                          <a:pt x="16200" y="10800"/>
                          <a:pt x="10800" y="30159"/>
                          <a:pt x="10800" y="49517"/>
                        </a:cubicBezTo>
                        <a:lnTo>
                          <a:pt x="10800" y="-17117"/>
                        </a:lnTo>
                        <a:cubicBezTo>
                          <a:pt x="10800" y="2242"/>
                          <a:pt x="5400" y="21600"/>
                          <a:pt x="0" y="21600"/>
                        </a:cubicBezTo>
                      </a:path>
                    </a:pathLst>
                  </a:custGeom>
                  <a:noFill/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ctr">
                    <a:noAutofit/>
                  </a:bodyPr>
                  <a:p>
                    <a:pPr algn="ctr"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01" name="Group 43"/>
                <p:cNvGrpSpPr/>
                <p:nvPr/>
              </p:nvGrpSpPr>
              <p:grpSpPr>
                <a:xfrm>
                  <a:off x="4834440" y="1238040"/>
                  <a:ext cx="1799640" cy="4969440"/>
                  <a:chOff x="4834440" y="1238040"/>
                  <a:chExt cx="1799640" cy="4969440"/>
                </a:xfrm>
              </p:grpSpPr>
              <p:sp>
                <p:nvSpPr>
                  <p:cNvPr id="202" name="TextBox 29"/>
                  <p:cNvSpPr/>
                  <p:nvPr/>
                </p:nvSpPr>
                <p:spPr>
                  <a:xfrm>
                    <a:off x="4834440" y="1238040"/>
                    <a:ext cx="13287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 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Kazachstania turicensis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TextBox 29"/>
                  <p:cNvSpPr/>
                  <p:nvPr/>
                </p:nvSpPr>
                <p:spPr>
                  <a:xfrm>
                    <a:off x="4834440" y="1632240"/>
                    <a:ext cx="13287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Kluyveromyces marxianus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TextBox 29"/>
                  <p:cNvSpPr/>
                  <p:nvPr/>
                </p:nvSpPr>
                <p:spPr>
                  <a:xfrm>
                    <a:off x="4834440" y="1886040"/>
                    <a:ext cx="13287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3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Pichia kudriavzevii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5" name="TextBox 29"/>
                  <p:cNvSpPr/>
                  <p:nvPr/>
                </p:nvSpPr>
                <p:spPr>
                  <a:xfrm>
                    <a:off x="4834440" y="2038320"/>
                    <a:ext cx="13287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4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Debaryomyces hansenii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TextBox 29"/>
                  <p:cNvSpPr/>
                  <p:nvPr/>
                </p:nvSpPr>
                <p:spPr>
                  <a:xfrm>
                    <a:off x="4834440" y="3017160"/>
                    <a:ext cx="132876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5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Kluyveromyces marxianus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TextBox 29"/>
                  <p:cNvSpPr/>
                  <p:nvPr/>
                </p:nvSpPr>
                <p:spPr>
                  <a:xfrm>
                    <a:off x="4834440" y="4059360"/>
                    <a:ext cx="17996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6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Geotrichum candidum/Galactomyces candidum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8" name="TextBox 29"/>
                  <p:cNvSpPr/>
                  <p:nvPr/>
                </p:nvSpPr>
                <p:spPr>
                  <a:xfrm>
                    <a:off x="4834440" y="4296960"/>
                    <a:ext cx="11509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7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Kluyveromyces marxianus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9" name="TextBox 29"/>
                  <p:cNvSpPr/>
                  <p:nvPr/>
                </p:nvSpPr>
                <p:spPr>
                  <a:xfrm>
                    <a:off x="4834440" y="4769280"/>
                    <a:ext cx="115164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8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Saccharomyces cerevisiae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0" name="TextBox 29"/>
                  <p:cNvSpPr/>
                  <p:nvPr/>
                </p:nvSpPr>
                <p:spPr>
                  <a:xfrm>
                    <a:off x="4834440" y="5493600"/>
                    <a:ext cx="11509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9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Saccharomyces cerevisiae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1" name="TextBox 29"/>
                  <p:cNvSpPr/>
                  <p:nvPr/>
                </p:nvSpPr>
                <p:spPr>
                  <a:xfrm>
                    <a:off x="4834440" y="5991840"/>
                    <a:ext cx="1150920" cy="2156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0</a:t>
                    </a:r>
                    <a:r>
                      <a:rPr b="1" lang="el-GR" sz="8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</a:t>
                    </a:r>
                    <a:r>
                      <a:rPr b="0" i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Yarrowia lipolytica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  <p:sp>
        <p:nvSpPr>
          <p:cNvPr id="212" name="TextBox 118"/>
          <p:cNvSpPr/>
          <p:nvPr/>
        </p:nvSpPr>
        <p:spPr>
          <a:xfrm>
            <a:off x="163440" y="6480000"/>
            <a:ext cx="652464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p-PCR fingerprinting of yeast isolates using the (GTG)5 primer. Image analysis was performed using BioNumerics v. 6.0. Arrows denote isolates, which were selected for ITS DNA region sequencing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09T07:03:18Z</dcterms:created>
  <dc:creator>Agriculture University of Athens</dc:creator>
  <dc:description/>
  <dc:language>en-US</dc:language>
  <cp:lastModifiedBy>Anastasia Sotiropoulou</cp:lastModifiedBy>
  <cp:lastPrinted>2020-10-12T08:58:46Z</cp:lastPrinted>
  <dcterms:modified xsi:type="dcterms:W3CDTF">2020-12-17T13:34:39Z</dcterms:modified>
  <cp:revision>50</cp:revision>
  <dc:subject/>
  <dc:title>Διαφάνεια 1</dc:title>
</cp:coreProperties>
</file>